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4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416" y="84"/>
      </p:cViewPr>
      <p:guideLst>
        <p:guide orient="horz" pos="284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11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6338" y="1233488"/>
            <a:ext cx="444500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43902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868556"/>
            <a:ext cx="799288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Keating et al (2017) Diabetologia DOI 10.1007/s00125-017-4490-1</a:t>
            </a:r>
          </a:p>
          <a:p>
            <a:r>
              <a:rPr lang="en-GB" sz="1400" dirty="0"/>
              <a:t>© The Author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odified signature of the diabetic epigenome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875D535-3F75-4514-9D9D-D6238400150C}"/>
              </a:ext>
            </a:extLst>
          </p:cNvPr>
          <p:cNvGrpSpPr/>
          <p:nvPr/>
        </p:nvGrpSpPr>
        <p:grpSpPr>
          <a:xfrm>
            <a:off x="1403648" y="692696"/>
            <a:ext cx="7560840" cy="4988189"/>
            <a:chOff x="1115616" y="889082"/>
            <a:chExt cx="7560840" cy="4988189"/>
          </a:xfrm>
        </p:grpSpPr>
        <p:sp>
          <p:nvSpPr>
            <p:cNvPr id="2" name="Rectangle 1"/>
            <p:cNvSpPr/>
            <p:nvPr/>
          </p:nvSpPr>
          <p:spPr>
            <a:xfrm>
              <a:off x="2339752" y="1556792"/>
              <a:ext cx="5112568" cy="302433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FIGURE HERE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6F8A43D-B6E2-4588-AF9F-4686C6206B2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15616" y="889082"/>
              <a:ext cx="7467699" cy="4988189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97BBB59E-A77A-4DB7-A848-AC8170E74481}"/>
                </a:ext>
              </a:extLst>
            </p:cNvPr>
            <p:cNvSpPr/>
            <p:nvPr/>
          </p:nvSpPr>
          <p:spPr>
            <a:xfrm>
              <a:off x="7452320" y="889082"/>
              <a:ext cx="1224136" cy="468178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A14CD605-AEB2-40B6-B298-74E1FE573637}"/>
                </a:ext>
              </a:extLst>
            </p:cNvPr>
            <p:cNvSpPr/>
            <p:nvPr/>
          </p:nvSpPr>
          <p:spPr>
            <a:xfrm>
              <a:off x="7812360" y="5570867"/>
              <a:ext cx="770955" cy="2880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Keating et al (2017) Diabetologia DOI 10.1007/s00125-017-4490-1</a:t>
            </a:r>
          </a:p>
          <a:p>
            <a:r>
              <a:rPr lang="en-GB" sz="1400" dirty="0"/>
              <a:t>© The Author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pigenetic and metabolic memory nexus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8EE7C8B-67BC-4414-9F2C-7645DE0E0E08}"/>
              </a:ext>
            </a:extLst>
          </p:cNvPr>
          <p:cNvSpPr/>
          <p:nvPr/>
        </p:nvSpPr>
        <p:spPr>
          <a:xfrm>
            <a:off x="2286000" y="3105835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endParaRPr lang="en-GB" dirty="0">
              <a:latin typeface="Times New Roman" panose="02020603050405020304" pitchFamily="18" charset="0"/>
            </a:endParaRPr>
          </a:p>
          <a:p>
            <a:endParaRPr lang="en-GB" dirty="0">
              <a:latin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C9259BA-5083-40E4-851A-758FA24696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520" y="1394143"/>
            <a:ext cx="4455653" cy="373046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D6442D0-AC5D-411A-BF5D-2FF7694771D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824" r="9791"/>
          <a:stretch/>
        </p:blipFill>
        <p:spPr>
          <a:xfrm>
            <a:off x="4632797" y="1628800"/>
            <a:ext cx="4335020" cy="3495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0903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43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32</cp:revision>
  <cp:lastPrinted>2017-10-26T09:16:33Z</cp:lastPrinted>
  <dcterms:created xsi:type="dcterms:W3CDTF">2016-06-15T12:53:43Z</dcterms:created>
  <dcterms:modified xsi:type="dcterms:W3CDTF">2017-11-10T13:32:29Z</dcterms:modified>
</cp:coreProperties>
</file>